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1" autoAdjust="0"/>
    <p:restoredTop sz="94660"/>
  </p:normalViewPr>
  <p:slideViewPr>
    <p:cSldViewPr snapToGrid="0">
      <p:cViewPr varScale="1">
        <p:scale>
          <a:sx n="45" d="100"/>
          <a:sy n="45" d="100"/>
        </p:scale>
        <p:origin x="34" y="97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ABDC6C-64D8-4B24-8417-70B39EACF18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410D7-C668-477C-9194-C1BB963381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4239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ABDC6C-64D8-4B24-8417-70B39EACF18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410D7-C668-477C-9194-C1BB963381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32571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ABDC6C-64D8-4B24-8417-70B39EACF18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410D7-C668-477C-9194-C1BB963381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81378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ABDC6C-64D8-4B24-8417-70B39EACF18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410D7-C668-477C-9194-C1BB963381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88859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ABDC6C-64D8-4B24-8417-70B39EACF18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410D7-C668-477C-9194-C1BB963381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11069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ABDC6C-64D8-4B24-8417-70B39EACF18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410D7-C668-477C-9194-C1BB963381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94311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ABDC6C-64D8-4B24-8417-70B39EACF18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410D7-C668-477C-9194-C1BB963381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70884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ABDC6C-64D8-4B24-8417-70B39EACF18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410D7-C668-477C-9194-C1BB963381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06687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ABDC6C-64D8-4B24-8417-70B39EACF18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410D7-C668-477C-9194-C1BB963381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10256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ABDC6C-64D8-4B24-8417-70B39EACF18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410D7-C668-477C-9194-C1BB963381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50301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ABDC6C-64D8-4B24-8417-70B39EACF18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410D7-C668-477C-9194-C1BB963381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9795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ABDC6C-64D8-4B24-8417-70B39EACF18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8410D7-C668-477C-9194-C1BB963381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48768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6717" y="721896"/>
            <a:ext cx="8625188" cy="4869564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Rectangle 1"/>
          <p:cNvSpPr>
            <a:spLocks noChangeArrowheads="1"/>
          </p:cNvSpPr>
          <p:nvPr/>
        </p:nvSpPr>
        <p:spPr bwMode="auto">
          <a:xfrm>
            <a:off x="1066800" y="5755185"/>
            <a:ext cx="11125200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vi-VN" altLang="en-US" sz="1200" b="1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Figure </a:t>
            </a: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S26</a:t>
            </a:r>
            <a:r>
              <a:rPr kumimoji="0" lang="vi-VN" altLang="en-US" sz="1200" b="1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. 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Correlation between β-</a:t>
            </a:r>
            <a:r>
              <a:rPr kumimoji="0" lang="en-US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haematin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inhibition activity (BIHA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, µM) and </a:t>
            </a:r>
            <a:r>
              <a:rPr kumimoji="0" lang="en-US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anti-malarial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activity (IC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­, µM) for xanthones against sensitive strain D6</a:t>
            </a: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. 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2-hydroxanthone, 1,3-dihydroxyxanthone, 2,3,4,5,6- pentaacetylxanthone were active against </a:t>
            </a:r>
            <a:r>
              <a:rPr kumimoji="0" lang="en-US" altLang="en-US" sz="1200" b="0" i="1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P. falciparum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D6 strain (IC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ranged from 0.075 – 75 µM) but did not possess the anti-</a:t>
            </a:r>
            <a:r>
              <a:rPr kumimoji="0" lang="en-US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haemozoin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activity (IC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&gt; 1000 µM)</a:t>
            </a: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rPr>
              <a:t> 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685721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4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MS Mincho</vt:lpstr>
      <vt:lpstr>Times New Roman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goc Nguyen</dc:creator>
  <cp:lastModifiedBy>Ngoc Nguyen</cp:lastModifiedBy>
  <cp:revision>2</cp:revision>
  <dcterms:created xsi:type="dcterms:W3CDTF">2020-07-03T16:17:44Z</dcterms:created>
  <dcterms:modified xsi:type="dcterms:W3CDTF">2020-08-04T16:36:51Z</dcterms:modified>
</cp:coreProperties>
</file>